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E9B38-A33B-468F-A681-B8A3B9A16B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395C6B-6927-4D6F-BFC4-E2358945C7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25277-5A91-4CF4-A4AD-8409668DBC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F7EF8-42AA-479A-92B8-B995E3BBEB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F936F-E08F-4B92-A9B1-70255410FA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8CFE4A-4A11-4BAF-8322-0E888B579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AB6D8-4BA7-4936-8E98-C9A259C235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C20C7F-8871-4092-81AD-353AD91C7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38E94-34C0-4D65-AF11-2818336F6F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E1661-44B4-467C-A265-83DC217E73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9AF2E-B765-41B0-9CFA-F1CBE9641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ED3AE-39BA-4B94-9B7B-5E11EB3607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7134A5-46D9-473A-B9DC-44C74664B6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6"/>
          <p:cNvSpPr/>
          <p:nvPr/>
        </p:nvSpPr>
        <p:spPr>
          <a:xfrm>
            <a:off x="533520" y="533520"/>
            <a:ext cx="336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21"/>
          <p:cNvSpPr/>
          <p:nvPr/>
        </p:nvSpPr>
        <p:spPr>
          <a:xfrm>
            <a:off x="2265480" y="2273400"/>
            <a:ext cx="315432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Oval 22"/>
          <p:cNvSpPr/>
          <p:nvPr/>
        </p:nvSpPr>
        <p:spPr>
          <a:xfrm>
            <a:off x="4684680" y="2125800"/>
            <a:ext cx="588960" cy="29340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p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23"/>
          <p:cNvSpPr/>
          <p:nvPr/>
        </p:nvSpPr>
        <p:spPr>
          <a:xfrm>
            <a:off x="2265480" y="1332000"/>
            <a:ext cx="3938400" cy="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24"/>
          <p:cNvSpPr/>
          <p:nvPr/>
        </p:nvSpPr>
        <p:spPr>
          <a:xfrm>
            <a:off x="2216160" y="1179360"/>
            <a:ext cx="38880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5"/>
          <p:cNvSpPr/>
          <p:nvPr/>
        </p:nvSpPr>
        <p:spPr>
          <a:xfrm>
            <a:off x="6004080" y="1179360"/>
            <a:ext cx="25704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26"/>
          <p:cNvSpPr/>
          <p:nvPr/>
        </p:nvSpPr>
        <p:spPr>
          <a:xfrm>
            <a:off x="4205160" y="1125360"/>
            <a:ext cx="457200" cy="409680"/>
          </a:xfrm>
          <a:prstGeom prst="rightArrow">
            <a:avLst>
              <a:gd name="adj1" fmla="val 50000"/>
              <a:gd name="adj2" fmla="val 27900"/>
            </a:avLst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F1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27"/>
          <p:cNvSpPr/>
          <p:nvPr/>
        </p:nvSpPr>
        <p:spPr>
          <a:xfrm>
            <a:off x="3251160" y="1125360"/>
            <a:ext cx="459000" cy="409680"/>
          </a:xfrm>
          <a:prstGeom prst="rightArrow">
            <a:avLst>
              <a:gd name="adj1" fmla="val 50000"/>
              <a:gd name="adj2" fmla="val 28010"/>
            </a:avLst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G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28"/>
          <p:cNvSpPr/>
          <p:nvPr/>
        </p:nvSpPr>
        <p:spPr>
          <a:xfrm>
            <a:off x="4673520" y="1179360"/>
            <a:ext cx="665280" cy="30492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29"/>
          <p:cNvSpPr/>
          <p:nvPr/>
        </p:nvSpPr>
        <p:spPr>
          <a:xfrm>
            <a:off x="3718080" y="1179360"/>
            <a:ext cx="460080" cy="30492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30"/>
          <p:cNvSpPr/>
          <p:nvPr/>
        </p:nvSpPr>
        <p:spPr>
          <a:xfrm>
            <a:off x="2136960" y="87480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’L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31"/>
          <p:cNvSpPr/>
          <p:nvPr/>
        </p:nvSpPr>
        <p:spPr>
          <a:xfrm>
            <a:off x="5840640" y="87480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’L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32"/>
          <p:cNvSpPr/>
          <p:nvPr/>
        </p:nvSpPr>
        <p:spPr>
          <a:xfrm>
            <a:off x="2216160" y="2120760"/>
            <a:ext cx="38880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3"/>
          <p:cNvSpPr/>
          <p:nvPr/>
        </p:nvSpPr>
        <p:spPr>
          <a:xfrm>
            <a:off x="5327640" y="2120760"/>
            <a:ext cx="25236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AutoShape 34"/>
          <p:cNvSpPr/>
          <p:nvPr/>
        </p:nvSpPr>
        <p:spPr>
          <a:xfrm>
            <a:off x="4205160" y="2068560"/>
            <a:ext cx="457200" cy="409680"/>
          </a:xfrm>
          <a:prstGeom prst="rightArrow">
            <a:avLst>
              <a:gd name="adj1" fmla="val 50000"/>
              <a:gd name="adj2" fmla="val 27900"/>
            </a:avLst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F1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35"/>
          <p:cNvSpPr/>
          <p:nvPr/>
        </p:nvSpPr>
        <p:spPr>
          <a:xfrm>
            <a:off x="3251160" y="2068560"/>
            <a:ext cx="459000" cy="409680"/>
          </a:xfrm>
          <a:prstGeom prst="rightArrow">
            <a:avLst>
              <a:gd name="adj1" fmla="val 50000"/>
              <a:gd name="adj2" fmla="val 28010"/>
            </a:avLst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G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36"/>
          <p:cNvSpPr/>
          <p:nvPr/>
        </p:nvSpPr>
        <p:spPr>
          <a:xfrm>
            <a:off x="3718080" y="2120760"/>
            <a:ext cx="460080" cy="30492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7"/>
          <p:cNvSpPr/>
          <p:nvPr/>
        </p:nvSpPr>
        <p:spPr>
          <a:xfrm>
            <a:off x="2152800" y="181764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’L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8"/>
          <p:cNvSpPr/>
          <p:nvPr/>
        </p:nvSpPr>
        <p:spPr>
          <a:xfrm>
            <a:off x="5145480" y="181764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’L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9"/>
          <p:cNvSpPr/>
          <p:nvPr/>
        </p:nvSpPr>
        <p:spPr>
          <a:xfrm>
            <a:off x="810000" y="1212840"/>
            <a:ext cx="104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GEW-Id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40"/>
          <p:cNvSpPr/>
          <p:nvPr/>
        </p:nvSpPr>
        <p:spPr>
          <a:xfrm>
            <a:off x="824400" y="2127240"/>
            <a:ext cx="130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GEW-emp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41"/>
          <p:cNvSpPr/>
          <p:nvPr/>
        </p:nvSpPr>
        <p:spPr>
          <a:xfrm>
            <a:off x="5362560" y="1181160"/>
            <a:ext cx="592200" cy="296640"/>
          </a:xfrm>
          <a:prstGeom prst="ellipse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p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42"/>
          <p:cNvSpPr/>
          <p:nvPr/>
        </p:nvSpPr>
        <p:spPr>
          <a:xfrm>
            <a:off x="2681280" y="1230480"/>
            <a:ext cx="0" cy="193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43"/>
          <p:cNvSpPr/>
          <p:nvPr/>
        </p:nvSpPr>
        <p:spPr>
          <a:xfrm>
            <a:off x="3197160" y="1230480"/>
            <a:ext cx="0" cy="193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4"/>
          <p:cNvSpPr/>
          <p:nvPr/>
        </p:nvSpPr>
        <p:spPr>
          <a:xfrm>
            <a:off x="2714760" y="1219320"/>
            <a:ext cx="195120" cy="1965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G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5"/>
          <p:cNvSpPr/>
          <p:nvPr/>
        </p:nvSpPr>
        <p:spPr>
          <a:xfrm>
            <a:off x="2894040" y="1219320"/>
            <a:ext cx="260280" cy="196560"/>
          </a:xfrm>
          <a:prstGeom prst="rect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RR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6"/>
          <p:cNvSpPr/>
          <p:nvPr/>
        </p:nvSpPr>
        <p:spPr>
          <a:xfrm>
            <a:off x="2675880" y="976320"/>
            <a:ext cx="27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ψ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7"/>
          <p:cNvSpPr/>
          <p:nvPr/>
        </p:nvSpPr>
        <p:spPr>
          <a:xfrm>
            <a:off x="2535480" y="1479600"/>
            <a:ext cx="33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8"/>
          <p:cNvSpPr/>
          <p:nvPr/>
        </p:nvSpPr>
        <p:spPr>
          <a:xfrm>
            <a:off x="3035520" y="1481040"/>
            <a:ext cx="33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49"/>
          <p:cNvSpPr/>
          <p:nvPr/>
        </p:nvSpPr>
        <p:spPr>
          <a:xfrm>
            <a:off x="2665440" y="2170080"/>
            <a:ext cx="0" cy="196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50"/>
          <p:cNvSpPr/>
          <p:nvPr/>
        </p:nvSpPr>
        <p:spPr>
          <a:xfrm>
            <a:off x="3181320" y="2170080"/>
            <a:ext cx="0" cy="196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1"/>
          <p:cNvSpPr/>
          <p:nvPr/>
        </p:nvSpPr>
        <p:spPr>
          <a:xfrm>
            <a:off x="2697120" y="2160720"/>
            <a:ext cx="196920" cy="1965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G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2"/>
          <p:cNvSpPr/>
          <p:nvPr/>
        </p:nvSpPr>
        <p:spPr>
          <a:xfrm>
            <a:off x="2876400" y="2160720"/>
            <a:ext cx="262080" cy="196560"/>
          </a:xfrm>
          <a:prstGeom prst="rect">
            <a:avLst/>
          </a:prstGeom>
          <a:solidFill>
            <a:srgbClr val="b2b2b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RR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53"/>
          <p:cNvSpPr/>
          <p:nvPr/>
        </p:nvSpPr>
        <p:spPr>
          <a:xfrm>
            <a:off x="2658600" y="1916280"/>
            <a:ext cx="27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ψ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54"/>
          <p:cNvSpPr/>
          <p:nvPr/>
        </p:nvSpPr>
        <p:spPr>
          <a:xfrm>
            <a:off x="2519640" y="2419200"/>
            <a:ext cx="33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55"/>
          <p:cNvSpPr/>
          <p:nvPr/>
        </p:nvSpPr>
        <p:spPr>
          <a:xfrm>
            <a:off x="3019680" y="2421000"/>
            <a:ext cx="339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1447920" y="3443400"/>
          <a:ext cx="2438280" cy="2192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47920" y="3443400"/>
                    <a:ext cx="2438280" cy="21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9" name="Text Box 16"/>
          <p:cNvSpPr/>
          <p:nvPr/>
        </p:nvSpPr>
        <p:spPr>
          <a:xfrm>
            <a:off x="533520" y="3397320"/>
            <a:ext cx="336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8900000">
            <a:off x="1829880" y="5729040"/>
            <a:ext cx="80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GEW-empt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8900000">
            <a:off x="2606760" y="569556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GEW-I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9T17:22:52Z</dcterms:created>
  <dc:creator>April Chan</dc:creator>
  <dc:description/>
  <dc:language>en-US</dc:language>
  <cp:lastModifiedBy>April Chan</cp:lastModifiedBy>
  <dcterms:modified xsi:type="dcterms:W3CDTF">2009-10-29T17:22:59Z</dcterms:modified>
  <cp:revision>1</cp:revision>
  <dc:subject/>
  <dc:title>Slide 1</dc:title>
</cp:coreProperties>
</file>